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61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235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146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70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10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650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650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56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720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96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71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E23D71-8071-4217-86FC-C5E85518AFA2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95234-645D-4CAD-A672-9A1570E3F3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35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2819" y="132901"/>
            <a:ext cx="6017802" cy="408134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962409" y="6494318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S1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6456" y="4214245"/>
            <a:ext cx="7559695" cy="2036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78632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0565" y="219179"/>
            <a:ext cx="3542788" cy="310770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214538" y="6463862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S2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1082566" y="3509207"/>
            <a:ext cx="8860220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. S2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 Binding of anti-F1 capsule mAb on F1 linear peptides does not show secondary positive bands like with V-antigen peptides.  To discern why V-antigen peptides 19, 20, 27, and 28 appeared to be recognized by anti-V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binding of mAb against F1 capsule was examined on V-antigen peptides as a control. 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were 10 µg/ml in PBS and 0.05 ml per well was used to probe the linear peptides and V- or F1- antigens. The binding assays were done twice in triplicate.  A.  The binding of mAb F1 (F1-04-A-G1) on F1 linear peptides is shown with the last lane as the positive control with full length F1 protein.  Note binding or peptides 1 and 2.  B.  The binding of mAb 84.1 on F1 linear peptides is shown as a control.  The last lane was the positive control with full length V-antigen.  Note that no positive peptides were seen with the mAb 84.1 unlike what was seen with the V-antigen peptides with this mAb (see Fig. S1).   C. The binding of mAb F1 on V- antigen peptides with the lane 54 showing the results with F1 protein and the last lane with full length V-antigen.  Note the appearance of the positive peptides 19, 20, 27, and 28.  From our results it was concluded that when both the V-antigen peptides and the secondary or detection antibody (conjugated with HRP) were used we saw nonspecific binding. We also looked at binding of the V-antigen peptides without the primary mAb and saw some positive binding of similar peptides but not as many or as high (data not shown). 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8988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4772" y="179551"/>
            <a:ext cx="5549870" cy="392999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962290" y="6085490"/>
            <a:ext cx="967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S3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2271707" y="451583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ig. S3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 The kinetic binding of V-antigen by anti-V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was analyzed by using an antibody capture method with a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iacor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3000 SPR instrument.  After capture of the anti-V mAb, different amounts of V-antigen (1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to 1.5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were passed over the immobilized mAb.  The results are shown with the follow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A. 84.1a; B. 84.1b; C. 141.1a; D. 141.1b; E. 7.3; F. 10.1.  The designation “a” means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unbiotinylate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and “b” means biotinylated mAb. The kinetic analysis for each mAb was done once as shown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1461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173"/>
          <a:stretch>
            <a:fillRect/>
          </a:stretch>
        </p:blipFill>
        <p:spPr bwMode="auto">
          <a:xfrm>
            <a:off x="3289260" y="616289"/>
            <a:ext cx="3585688" cy="26635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0909738" y="6432331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S4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2438400" y="3629486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4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The deficiency of binding of V-antigen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74.1 was analyzed with a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acor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3000 SPR instrument. Compare the kinetic binding of V-antigen by mAb 74.1 with the binding of the other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b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Fig. S3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2155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58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D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emiya, Kei Dr. VOL USARMY MEDCOM USAMRIID (US)</dc:creator>
  <cp:lastModifiedBy>Amemiya, Kei Dr. VOL USARMY MEDCOM USAMRIID (US)</cp:lastModifiedBy>
  <cp:revision>9</cp:revision>
  <dcterms:created xsi:type="dcterms:W3CDTF">2020-07-21T18:26:21Z</dcterms:created>
  <dcterms:modified xsi:type="dcterms:W3CDTF">2020-07-21T18:59:45Z</dcterms:modified>
</cp:coreProperties>
</file>